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5" d="100"/>
          <a:sy n="65" d="100"/>
        </p:scale>
        <p:origin x="69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2" Type="http://schemas.openxmlformats.org/officeDocument/2006/relationships/slide" Target="slides/slide1.xml"/>
   <Relationship Id="rId3" Type="http://schemas.openxmlformats.org/officeDocument/2006/relationships/presProps" Target="presProps.xml"/>
   <Relationship Id="rId4" Type="http://schemas.openxmlformats.org/officeDocument/2006/relationships/viewProps" Target="viewProps.xml"/>
   <Relationship Id="rId5" Type="http://schemas.openxmlformats.org/officeDocument/2006/relationships/theme" Target="theme/theme1.xml"/>
   <Relationship Id="rId6" Type="http://schemas.openxmlformats.org/officeDocument/2006/relationships/tableStyles" Target="tableStyles.xml"/>
</Relationships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1C959-D06E-44FE-8172-4A2EFB75B13D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4FC12-90FD-4539-BC88-673999587A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69177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1C959-D06E-44FE-8172-4A2EFB75B13D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4FC12-90FD-4539-BC88-673999587A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69954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1C959-D06E-44FE-8172-4A2EFB75B13D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4FC12-90FD-4539-BC88-673999587A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94673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1C959-D06E-44FE-8172-4A2EFB75B13D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4FC12-90FD-4539-BC88-673999587A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78397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1C959-D06E-44FE-8172-4A2EFB75B13D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4FC12-90FD-4539-BC88-673999587A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41044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1C959-D06E-44FE-8172-4A2EFB75B13D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4FC12-90FD-4539-BC88-673999587A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67575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1C959-D06E-44FE-8172-4A2EFB75B13D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4FC12-90FD-4539-BC88-673999587A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33815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1C959-D06E-44FE-8172-4A2EFB75B13D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4FC12-90FD-4539-BC88-673999587A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29313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1C959-D06E-44FE-8172-4A2EFB75B13D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4FC12-90FD-4539-BC88-673999587A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49804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1C959-D06E-44FE-8172-4A2EFB75B13D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4FC12-90FD-4539-BC88-673999587A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30934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1C959-D06E-44FE-8172-4A2EFB75B13D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4FC12-90FD-4539-BC88-673999587A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0714590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F1C959-D06E-44FE-8172-4A2EFB75B13D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F4FC12-90FD-4539-BC88-673999587A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2857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61251430"/>
              </p:ext>
            </p:extLst>
          </p:nvPr>
        </p:nvGraphicFramePr>
        <p:xfrm>
          <a:off x="978338" y="282619"/>
          <a:ext cx="5295000" cy="3862808"/>
        </p:xfrm>
        <a:graphic>
          <a:graphicData uri="http://schemas.openxmlformats.org/drawingml/2006/table">
            <a:tbl>
              <a:tblPr/>
              <a:tblGrid>
                <a:gridCol w="882500"/>
                <a:gridCol w="882500"/>
                <a:gridCol w="882500"/>
                <a:gridCol w="882500"/>
                <a:gridCol w="882500"/>
                <a:gridCol w="882500"/>
              </a:tblGrid>
              <a:tr h="227224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D</a:t>
                      </a:r>
                    </a:p>
                  </a:txBody>
                  <a:tcPr marL="3810" marR="3810" marT="38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27224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dpi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 dpi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dpi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 dpi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27224">
                <a:tc rowSpan="3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</a:t>
                      </a:r>
                      <a:r>
                        <a:rPr lang="en-GB" sz="1100" b="1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Ø</a:t>
                      </a:r>
                      <a:endParaRPr lang="en-GB" sz="1400" b="1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Ø_1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</a:tr>
              <a:tr h="22722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Ø_2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722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Ø_3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</a:tr>
              <a:tr h="227224">
                <a:tc rowSpan="3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Z+W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Z+W_1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722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Z+W_2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722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Z+W_3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27224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Z-s-W</a:t>
                      </a:r>
                    </a:p>
                  </a:txBody>
                  <a:tcPr marL="3810" marR="3810" marT="381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Z-s-W_1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722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Z-s-W_2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22722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Z-s-W_3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27224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Z-m-W</a:t>
                      </a:r>
                    </a:p>
                  </a:txBody>
                  <a:tcPr marL="3810" marR="3810" marT="381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Z-m-W_1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22722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Z-m-W_2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</a:tr>
              <a:tr h="22722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Z-m-W_3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</a:tr>
              <a:tr h="227224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Z-lg-W</a:t>
                      </a:r>
                    </a:p>
                  </a:txBody>
                  <a:tcPr marL="3810" marR="3810" marT="381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Z-lg-W_1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</a:tr>
              <a:tr h="22722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Z-lg-W_2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722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Z-lg-W_3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755912" y="4356017"/>
            <a:ext cx="6789623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>
              <a:defRPr/>
            </a:pPr>
            <a:r>
              <a:rPr kumimoji="0" lang="en-GB" sz="16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</a:t>
            </a:r>
            <a:r>
              <a:rPr kumimoji="0" lang="en-GB" sz="1600" b="1" i="0" u="none" strike="noStrike" kern="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5. </a:t>
            </a:r>
            <a:r>
              <a:rPr kumimoji="0" lang="en-GB" sz="1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Number of</a:t>
            </a:r>
            <a:r>
              <a:rPr kumimoji="0" lang="en-GB" sz="1600" b="0" i="0" u="none" strike="noStrike" kern="0" cap="none" spc="0" normalizeH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leaves harvested per day post infiltration (dpi) for </a:t>
            </a:r>
            <a:r>
              <a:rPr lang="en-GB" sz="1600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GB" sz="1600" i="1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. benthamiana </a:t>
            </a:r>
            <a:r>
              <a:rPr lang="en-GB" sz="1600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gro-infiltration experiment 2. </a:t>
            </a:r>
            <a:r>
              <a:rPr kumimoji="0" lang="en-GB" sz="1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In this experiment, leaves</a:t>
            </a:r>
            <a:r>
              <a:rPr kumimoji="0" lang="en-GB" sz="1600" b="0" i="0" u="none" strike="noStrike" kern="0" cap="none" spc="0" normalizeH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were collected when they started to show the first symptoms of senescence or at 7 dpi, the </a:t>
            </a:r>
            <a:r>
              <a:rPr kumimoji="0" lang="en-GB" sz="1600" b="0" i="0" u="none" strike="noStrike" kern="0" cap="none" spc="0" normalizeH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en</a:t>
            </a:r>
            <a:r>
              <a:rPr lang="en-GB" sz="1600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 of the experiment</a:t>
            </a:r>
            <a:r>
              <a:rPr kumimoji="0" lang="en-GB" sz="1600" b="0" i="0" u="none" strike="noStrike" kern="0" cap="none" spc="0" normalizeH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. The table describes the number of leaves harvested for the three plants per construct.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Ø, empty vector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Z+W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vidual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Z &amp; 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; </a:t>
            </a:r>
            <a:r>
              <a:rPr lang="en-GB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Z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W, Z &amp; W fusions with the small, medium and long 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ker.</a:t>
            </a:r>
            <a:endParaRPr kumimoji="0" lang="en-GB" sz="16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260903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4</TotalTime>
  <Words>156</Words>
  <Application>Microsoft Office PowerPoint</Application>
  <PresentationFormat>Widescreen</PresentationFormat>
  <Paragraphs>9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  <Template/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